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8" r:id="rId2"/>
    <p:sldId id="269" r:id="rId3"/>
    <p:sldId id="262" r:id="rId4"/>
    <p:sldId id="270" r:id="rId5"/>
    <p:sldId id="271" r:id="rId6"/>
  </p:sldIdLst>
  <p:sldSz cx="6858000" cy="9144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04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indows 사용자" initials="W사" lastIdx="2" clrIdx="0"/>
  <p:cmAuthor id="1" name="user" initials="u" lastIdx="1" clrIdx="1"/>
  <p:cmAuthor id="2" name="KIM Hyun Uk" initials="KHU" lastIdx="1" clrIdx="2">
    <p:extLst>
      <p:ext uri="{19B8F6BF-5375-455C-9EA6-DF929625EA0E}">
        <p15:presenceInfo xmlns:p15="http://schemas.microsoft.com/office/powerpoint/2012/main" userId="7f04f9e1e8b8a42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03" autoAdjust="0"/>
    <p:restoredTop sz="94103" autoAdjust="0"/>
  </p:normalViewPr>
  <p:slideViewPr>
    <p:cSldViewPr showGuides="1">
      <p:cViewPr varScale="1">
        <p:scale>
          <a:sx n="85" d="100"/>
          <a:sy n="85" d="100"/>
        </p:scale>
        <p:origin x="2784" y="96"/>
      </p:cViewPr>
      <p:guideLst>
        <p:guide orient="horz" pos="4604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767E4F-8D3D-4CBD-8D0B-6C0B5706E6EE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60B0B4-95E6-4512-81E4-83556D84FA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715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1E633-36D4-41FB-B2C8-F2BDBD133A87}" type="datetimeFigureOut">
              <a:rPr lang="ko-KR" altLang="en-US" smtClean="0"/>
              <a:pPr/>
              <a:t>2022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B0B3F0-C91C-4297-AC0E-E574C9AD30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55952" y="5971202"/>
            <a:ext cx="646929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DNA insertion knock-out mutant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DNA inserted in the second intron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ch has four exons and three introns. ATG: translation start codon; TAA: translation stop codon; 5′-end: primer site for N-terminus; 3′-end: primer site for C-terminus; LP: left primer binding site; RP: right primer binding site; LBb1.3: T-DNA left border primer; q5: forward primer for RT-qPCR; q3: reverse primer for RT-qPCR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type of wild type (WT)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zygous mutant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(C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PCR analysis of WT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zygous mutant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(D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qPCR analysis of WT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zygous mutant. ND: none detected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922383" y="1570914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dpbf2-1</a:t>
            </a:r>
            <a:endParaRPr lang="ko-KR" altLang="en-US" sz="1200" b="1" i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grpSp>
        <p:nvGrpSpPr>
          <p:cNvPr id="91" name="그룹 90"/>
          <p:cNvGrpSpPr/>
          <p:nvPr/>
        </p:nvGrpSpPr>
        <p:grpSpPr>
          <a:xfrm>
            <a:off x="451840" y="3687758"/>
            <a:ext cx="1686191" cy="867988"/>
            <a:chOff x="1068950" y="4950925"/>
            <a:chExt cx="1686191" cy="867988"/>
          </a:xfrm>
        </p:grpSpPr>
        <p:sp>
          <p:nvSpPr>
            <p:cNvPr id="70" name="TextBox 69"/>
            <p:cNvSpPr txBox="1"/>
            <p:nvPr/>
          </p:nvSpPr>
          <p:spPr>
            <a:xfrm>
              <a:off x="1485712" y="4950925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WT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014233" y="4969461"/>
              <a:ext cx="740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itchFamily="34" charset="0"/>
                  <a:cs typeface="Arial" pitchFamily="34" charset="0"/>
                </a:rPr>
                <a:t>dpbf2-1</a:t>
              </a:r>
              <a:endParaRPr lang="ko-KR" altLang="en-US" sz="12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068950" y="554191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1.2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2" name="그룹 91"/>
          <p:cNvGrpSpPr/>
          <p:nvPr/>
        </p:nvGrpSpPr>
        <p:grpSpPr>
          <a:xfrm>
            <a:off x="2280614" y="3573572"/>
            <a:ext cx="2382091" cy="1373942"/>
            <a:chOff x="3319872" y="4932040"/>
            <a:chExt cx="2382091" cy="1373942"/>
          </a:xfrm>
        </p:grpSpPr>
        <p:sp>
          <p:nvSpPr>
            <p:cNvPr id="74" name="TextBox 73"/>
            <p:cNvSpPr txBox="1"/>
            <p:nvPr/>
          </p:nvSpPr>
          <p:spPr>
            <a:xfrm>
              <a:off x="4407672" y="4990872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WT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736780" y="4976819"/>
              <a:ext cx="740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itchFamily="34" charset="0"/>
                  <a:cs typeface="Arial" pitchFamily="34" charset="0"/>
                </a:rPr>
                <a:t>dpbf2-1</a:t>
              </a:r>
              <a:endParaRPr lang="ko-KR" altLang="en-US" sz="12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933056" y="4932040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1kb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517232" y="4932040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319872" y="5406196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itchFamily="34" charset="0"/>
                  <a:cs typeface="Arial" pitchFamily="34" charset="0"/>
                </a:rPr>
                <a:t>DPBF2</a:t>
              </a:r>
              <a:endParaRPr lang="ko-KR" altLang="en-US" sz="12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427446" y="6028983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itchFamily="34" charset="0"/>
                  <a:cs typeface="Arial" pitchFamily="34" charset="0"/>
                </a:rPr>
                <a:t>ACT2</a:t>
              </a:r>
              <a:endParaRPr lang="ko-KR" altLang="en-US" sz="1200" b="1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317138" y="18479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46606" y="3511289"/>
            <a:ext cx="436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>
                <a:latin typeface="Arial" pitchFamily="34" charset="0"/>
                <a:cs typeface="Arial" pitchFamily="34" charset="0"/>
              </a:rPr>
              <a:t>B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367245" y="352604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>
                <a:latin typeface="Arial" pitchFamily="34" charset="0"/>
                <a:cs typeface="Arial" pitchFamily="34" charset="0"/>
              </a:rPr>
              <a:t>C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274" y="3933433"/>
            <a:ext cx="1370544" cy="1126892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432011" y="457287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0.6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63083" y="386515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(kb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067684" y="2389819"/>
            <a:ext cx="1775020" cy="1606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직사각형 71"/>
          <p:cNvSpPr/>
          <p:nvPr/>
        </p:nvSpPr>
        <p:spPr>
          <a:xfrm>
            <a:off x="3167056" y="2401646"/>
            <a:ext cx="167430" cy="14877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직사각형 79"/>
          <p:cNvSpPr/>
          <p:nvPr/>
        </p:nvSpPr>
        <p:spPr>
          <a:xfrm>
            <a:off x="3590767" y="2401646"/>
            <a:ext cx="45719" cy="15805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1" name="직사각형 80"/>
          <p:cNvSpPr/>
          <p:nvPr/>
        </p:nvSpPr>
        <p:spPr>
          <a:xfrm>
            <a:off x="4428645" y="2410932"/>
            <a:ext cx="167430" cy="14877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7" name="직선 연결선 6"/>
          <p:cNvCxnSpPr/>
          <p:nvPr/>
        </p:nvCxnSpPr>
        <p:spPr>
          <a:xfrm flipV="1">
            <a:off x="774127" y="2477151"/>
            <a:ext cx="4884977" cy="55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화살표 연결선 8"/>
          <p:cNvCxnSpPr/>
          <p:nvPr/>
        </p:nvCxnSpPr>
        <p:spPr>
          <a:xfrm flipH="1">
            <a:off x="4820593" y="2353286"/>
            <a:ext cx="21602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 flipV="1">
            <a:off x="3371865" y="2227737"/>
            <a:ext cx="0" cy="2423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이등변 삼각형 15"/>
          <p:cNvSpPr/>
          <p:nvPr/>
        </p:nvSpPr>
        <p:spPr>
          <a:xfrm rot="10800000">
            <a:off x="3204283" y="2069224"/>
            <a:ext cx="339996" cy="160200"/>
          </a:xfrm>
          <a:prstGeom prst="triangl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0" name="직선 연결선 19"/>
          <p:cNvCxnSpPr/>
          <p:nvPr/>
        </p:nvCxnSpPr>
        <p:spPr>
          <a:xfrm>
            <a:off x="5391030" y="2227761"/>
            <a:ext cx="210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화살표 연결선 22"/>
          <p:cNvCxnSpPr/>
          <p:nvPr/>
        </p:nvCxnSpPr>
        <p:spPr>
          <a:xfrm>
            <a:off x="2507843" y="2337258"/>
            <a:ext cx="216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화살표 연결선 86"/>
          <p:cNvCxnSpPr/>
          <p:nvPr/>
        </p:nvCxnSpPr>
        <p:spPr>
          <a:xfrm>
            <a:off x="1103687" y="2666750"/>
            <a:ext cx="216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화살표 연결선 88"/>
          <p:cNvCxnSpPr/>
          <p:nvPr/>
        </p:nvCxnSpPr>
        <p:spPr>
          <a:xfrm flipH="1">
            <a:off x="4404348" y="2746224"/>
            <a:ext cx="21602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화살표 연결선 89"/>
          <p:cNvCxnSpPr/>
          <p:nvPr/>
        </p:nvCxnSpPr>
        <p:spPr>
          <a:xfrm flipH="1">
            <a:off x="3173251" y="2018745"/>
            <a:ext cx="19861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395296" y="2066277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R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741126" y="2098619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L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980310" y="1779948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LBb1.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301314" y="1962352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0.1k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83539" y="2663975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5’-end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273829" y="2748660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3’-end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977992" y="2179537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T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231269" y="220233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TA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2704" y="3865152"/>
            <a:ext cx="1560711" cy="1261981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3001" y="3705266"/>
            <a:ext cx="1776309" cy="1696573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4512360" y="35125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>
                <a:latin typeface="Arial" pitchFamily="34" charset="0"/>
                <a:cs typeface="Arial" pitchFamily="34" charset="0"/>
              </a:rPr>
              <a:t>D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188640" y="251520"/>
            <a:ext cx="5877272" cy="3356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0"/>
              </a:spcAft>
            </a:pPr>
            <a:r>
              <a:rPr lang="en-US" altLang="ko-KR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cxnSp>
        <p:nvCxnSpPr>
          <p:cNvPr id="46" name="직선 화살표 연결선 45"/>
          <p:cNvCxnSpPr/>
          <p:nvPr/>
        </p:nvCxnSpPr>
        <p:spPr>
          <a:xfrm flipH="1">
            <a:off x="4380051" y="2646075"/>
            <a:ext cx="21602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화살표 연결선 47"/>
          <p:cNvCxnSpPr/>
          <p:nvPr/>
        </p:nvCxnSpPr>
        <p:spPr>
          <a:xfrm>
            <a:off x="2586214" y="2639963"/>
            <a:ext cx="216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342477" y="250942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q5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545542" y="250797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q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7293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908720" y="5508104"/>
            <a:ext cx="547260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 fatty acid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content analysis i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and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. No statistically significant differences between the WT and mutant lines were determined by two-way ANOVA with Bonferroni post-tests. Data represent the mean (± SE) from three independent biological replicates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4784" y="2627784"/>
            <a:ext cx="4176464" cy="2664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4910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22083" y="7430218"/>
            <a:ext cx="641383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: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WT plants. (A) The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-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ctor containing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NA under control of 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V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5S promoter. (B) RT-qPCR analysis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 in leaf of </a:t>
            </a:r>
            <a:r>
              <a:rPr lang="en-US" altLang="ko-KR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35S-DPBF2</a:t>
            </a:r>
            <a:r>
              <a:rPr lang="en-US" altLang="ko-KR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T2 lines. Statistically significant differences are indicated by One-Way ANOVA with tukey t-tests (*** </a:t>
            </a:r>
            <a:r>
              <a:rPr lang="en-US" altLang="ko-KR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 &lt;0.001). (C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tty acid composition in WT seeds and the T2 seeds of individual </a:t>
            </a:r>
            <a:r>
              <a:rPr lang="en-US" altLang="ko-KR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35S-DPBF2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 T1 lin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tatistically significant differences are indicated by Two-Way ANOVA with Bonferroni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post-tests (*** </a:t>
            </a:r>
            <a:r>
              <a:rPr lang="en-US" altLang="ko-KR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). Fatty acid content represent the mean (± SD) from three technical replicates of wild-type (WT) and nine independent overexpressed lines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-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analyzed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그룹 19">
            <a:extLst>
              <a:ext uri="{FF2B5EF4-FFF2-40B4-BE49-F238E27FC236}">
                <a16:creationId xmlns="" xmlns:a16="http://schemas.microsoft.com/office/drawing/2014/main" id="{DA2A4E42-07BD-4FA6-8A8C-EB66E3B49CDB}"/>
              </a:ext>
            </a:extLst>
          </p:cNvPr>
          <p:cNvGrpSpPr/>
          <p:nvPr/>
        </p:nvGrpSpPr>
        <p:grpSpPr>
          <a:xfrm>
            <a:off x="1412776" y="179512"/>
            <a:ext cx="4243263" cy="867535"/>
            <a:chOff x="1292101" y="1115616"/>
            <a:chExt cx="4243263" cy="867535"/>
          </a:xfrm>
        </p:grpSpPr>
        <p:cxnSp>
          <p:nvCxnSpPr>
            <p:cNvPr id="23" name="직선 연결선 22"/>
            <p:cNvCxnSpPr/>
            <p:nvPr/>
          </p:nvCxnSpPr>
          <p:spPr>
            <a:xfrm flipV="1">
              <a:off x="1397322" y="1711927"/>
              <a:ext cx="3988150" cy="2417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그룹 30"/>
            <p:cNvGrpSpPr/>
            <p:nvPr/>
          </p:nvGrpSpPr>
          <p:grpSpPr>
            <a:xfrm>
              <a:off x="1292101" y="1248379"/>
              <a:ext cx="4243263" cy="734772"/>
              <a:chOff x="2233919" y="485473"/>
              <a:chExt cx="4243263" cy="734772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233919" y="522095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071302" y="485473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" name="그룹 57"/>
              <p:cNvGrpSpPr/>
              <p:nvPr/>
            </p:nvGrpSpPr>
            <p:grpSpPr>
              <a:xfrm>
                <a:off x="2307827" y="696921"/>
                <a:ext cx="4070265" cy="523324"/>
                <a:chOff x="1847372" y="3068959"/>
                <a:chExt cx="4655734" cy="648073"/>
              </a:xfrm>
            </p:grpSpPr>
            <p:sp>
              <p:nvSpPr>
                <p:cNvPr id="35" name="오른쪽 화살표 34"/>
                <p:cNvSpPr/>
                <p:nvPr/>
              </p:nvSpPr>
              <p:spPr>
                <a:xfrm>
                  <a:off x="3131840" y="3110902"/>
                  <a:ext cx="1154408" cy="576064"/>
                </a:xfrm>
                <a:prstGeom prst="rightArrow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오른쪽 화살표 35"/>
                <p:cNvSpPr/>
                <p:nvPr/>
              </p:nvSpPr>
              <p:spPr>
                <a:xfrm rot="10800000">
                  <a:off x="2165612" y="3068959"/>
                  <a:ext cx="750203" cy="648072"/>
                </a:xfrm>
                <a:prstGeom prst="rightArrow">
                  <a:avLst/>
                </a:prstGeom>
                <a:solidFill>
                  <a:srgbClr val="00B05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오른쪽 화살표 36"/>
                <p:cNvSpPr/>
                <p:nvPr/>
              </p:nvSpPr>
              <p:spPr>
                <a:xfrm>
                  <a:off x="5580112" y="3068960"/>
                  <a:ext cx="685417" cy="648072"/>
                </a:xfrm>
                <a:prstGeom prst="rightArrow">
                  <a:avLst>
                    <a:gd name="adj1" fmla="val 50000"/>
                    <a:gd name="adj2" fmla="val 52009"/>
                  </a:avLst>
                </a:prstGeom>
                <a:solidFill>
                  <a:srgbClr val="00B0F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rIns="0" rtlCol="0" anchor="ctr"/>
                <a:lstStyle/>
                <a:p>
                  <a:pPr algn="ctr"/>
                  <a:endParaRPr lang="ko-KR" alt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8" name="그룹 36"/>
                <p:cNvGrpSpPr/>
                <p:nvPr/>
              </p:nvGrpSpPr>
              <p:grpSpPr>
                <a:xfrm>
                  <a:off x="1847372" y="3132986"/>
                  <a:ext cx="288032" cy="288032"/>
                  <a:chOff x="848388" y="1971730"/>
                  <a:chExt cx="288032" cy="288032"/>
                </a:xfrm>
              </p:grpSpPr>
              <p:cxnSp>
                <p:nvCxnSpPr>
                  <p:cNvPr id="44" name="직선 연결선 43"/>
                  <p:cNvCxnSpPr/>
                  <p:nvPr/>
                </p:nvCxnSpPr>
                <p:spPr>
                  <a:xfrm flipV="1">
                    <a:off x="992404" y="1971730"/>
                    <a:ext cx="0" cy="28803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직선 연결선 44"/>
                  <p:cNvCxnSpPr/>
                  <p:nvPr/>
                </p:nvCxnSpPr>
                <p:spPr>
                  <a:xfrm>
                    <a:off x="848388" y="1980489"/>
                    <a:ext cx="2880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9" name="그룹 39"/>
                <p:cNvGrpSpPr/>
                <p:nvPr/>
              </p:nvGrpSpPr>
              <p:grpSpPr>
                <a:xfrm>
                  <a:off x="6215074" y="3093122"/>
                  <a:ext cx="288032" cy="288032"/>
                  <a:chOff x="764704" y="1931296"/>
                  <a:chExt cx="288032" cy="288032"/>
                </a:xfrm>
              </p:grpSpPr>
              <p:cxnSp>
                <p:nvCxnSpPr>
                  <p:cNvPr id="42" name="직선 연결선 41"/>
                  <p:cNvCxnSpPr/>
                  <p:nvPr/>
                </p:nvCxnSpPr>
                <p:spPr>
                  <a:xfrm flipV="1">
                    <a:off x="908721" y="1931296"/>
                    <a:ext cx="0" cy="28803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직선 연결선 42"/>
                  <p:cNvCxnSpPr/>
                  <p:nvPr/>
                </p:nvCxnSpPr>
                <p:spPr>
                  <a:xfrm>
                    <a:off x="764704" y="1931296"/>
                    <a:ext cx="2880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0" name="TextBox 39"/>
                <p:cNvSpPr txBox="1"/>
                <p:nvPr/>
              </p:nvSpPr>
              <p:spPr>
                <a:xfrm>
                  <a:off x="2286981" y="3236536"/>
                  <a:ext cx="607282" cy="3239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BAR</a:t>
                  </a:r>
                  <a:endParaRPr lang="ko-KR" altLang="en-US" sz="11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오른쪽 화살표 40"/>
                <p:cNvSpPr/>
                <p:nvPr/>
              </p:nvSpPr>
              <p:spPr>
                <a:xfrm>
                  <a:off x="4286248" y="3113751"/>
                  <a:ext cx="1285884" cy="576064"/>
                </a:xfrm>
                <a:prstGeom prst="rightArrow">
                  <a:avLst/>
                </a:prstGeom>
                <a:solidFill>
                  <a:srgbClr val="C000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1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PBF2</a:t>
                  </a:r>
                  <a:endParaRPr lang="ko-KR" altLang="en-US" sz="11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6" name="TextBox 45"/>
            <p:cNvSpPr txBox="1"/>
            <p:nvPr/>
          </p:nvSpPr>
          <p:spPr>
            <a:xfrm>
              <a:off x="2908121" y="1115616"/>
              <a:ext cx="10823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latin typeface="Arial" pitchFamily="34" charset="0"/>
                  <a:cs typeface="Arial" pitchFamily="34" charset="0"/>
                </a:rPr>
                <a:t>OX-DPBF2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직사각형 46"/>
            <p:cNvSpPr/>
            <p:nvPr/>
          </p:nvSpPr>
          <p:spPr>
            <a:xfrm>
              <a:off x="2479825" y="1602065"/>
              <a:ext cx="96212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MV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35SP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574227" y="1602364"/>
              <a:ext cx="6543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OCS T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957387" y="4694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>
                <a:latin typeface="Arial" pitchFamily="34" charset="0"/>
                <a:cs typeface="Arial" pitchFamily="34" charset="0"/>
              </a:rPr>
              <a:t>A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2586" y="4418787"/>
            <a:ext cx="6858000" cy="2982439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1080634" y="13192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409" y="42287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="" xmlns:a16="http://schemas.microsoft.com/office/drawing/2014/main" id="{14107E9F-DF78-4B6D-A7FC-5F94FA0177C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776" y="1335064"/>
            <a:ext cx="3632209" cy="301887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188640" y="4644008"/>
            <a:ext cx="628795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fatty acid composition of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and three independent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+Ph-DPBF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2 generation transgenic plants.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+Ph-DPBF2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a Ph-DPBF2 vector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forman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t seed-specifically overexpresses DPBF2 in the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bf2-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Statistically significant differences are indicated by Two-Way ANOVA with Bonferroni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post-tests </a:t>
            </a:r>
            <a:r>
              <a:rPr lang="nn-NO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(*** </a:t>
            </a:r>
            <a:r>
              <a:rPr lang="nn-NO" altLang="ko-KR" sz="1200" i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n-NO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n-NO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Fatty acid content represent the mean (± SE) from three independent biological replicates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704" y="1691680"/>
            <a:ext cx="5335524" cy="2674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7295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="" xmlns:a16="http://schemas.microsoft.com/office/drawing/2014/main" id="{A7945C1D-7F06-488B-95BB-9DEBAE43CD07}"/>
              </a:ext>
            </a:extLst>
          </p:cNvPr>
          <p:cNvSpPr/>
          <p:nvPr/>
        </p:nvSpPr>
        <p:spPr>
          <a:xfrm>
            <a:off x="188640" y="6444208"/>
            <a:ext cx="628795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lement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in the promoter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 of six genes. Putative DPBF2-binding G-box (ACGT) and L1L-(NF-YC2)-binding motif (CCAAT) are described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by arrowheads in both of forward and reverse direction.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="" xmlns:a16="http://schemas.microsoft.com/office/drawing/2014/main" id="{CE53D1FE-DA79-4BD3-8664-E2AF616F6C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552" y="1835696"/>
            <a:ext cx="5566130" cy="4310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860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81</TotalTime>
  <Words>470</Words>
  <Application>Microsoft Office PowerPoint</Application>
  <PresentationFormat>화면 슬라이드 쇼(4:3)</PresentationFormat>
  <Paragraphs>41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Arial Unicode MS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hp</cp:lastModifiedBy>
  <cp:revision>198</cp:revision>
  <cp:lastPrinted>2019-10-03T07:06:38Z</cp:lastPrinted>
  <dcterms:created xsi:type="dcterms:W3CDTF">2014-04-14T10:28:48Z</dcterms:created>
  <dcterms:modified xsi:type="dcterms:W3CDTF">2022-03-07T07:16:33Z</dcterms:modified>
</cp:coreProperties>
</file>